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94" d="100"/>
          <a:sy n="94" d="100"/>
        </p:scale>
        <p:origin x="-77" y="-53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B82830-24BB-4962-88B5-0B4E57228741}" type="slidenum">
              <a:rPr 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041590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E5020FB-0649-4291-9A59-B9663BEDCDA7}" type="slidenum">
              <a:rPr 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226862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250E223-C224-41E3-8586-BE955521BECB}" type="slidenum">
              <a:rPr 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4966786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 and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sz="quarter"/>
          </p:nvPr>
        </p:nvSpPr>
        <p:spPr>
          <a:xfrm>
            <a:off x="342900" y="366713"/>
            <a:ext cx="6172200" cy="15240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>
          <a:xfrm>
            <a:off x="342900" y="2133600"/>
            <a:ext cx="3009900" cy="294005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quarter" idx="2"/>
          </p:nvPr>
        </p:nvSpPr>
        <p:spPr>
          <a:xfrm>
            <a:off x="3505200" y="2133600"/>
            <a:ext cx="3009900" cy="294005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Content Placeholder 4"/>
          <p:cNvSpPr>
            <a:spLocks noGrp="1"/>
          </p:cNvSpPr>
          <p:nvPr>
            <p:ph sz="quarter" idx="3"/>
          </p:nvPr>
        </p:nvSpPr>
        <p:spPr>
          <a:xfrm>
            <a:off x="342900" y="5226050"/>
            <a:ext cx="3009900" cy="29416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505200" y="5226050"/>
            <a:ext cx="3009900" cy="29416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7AD2434-DFF5-493C-BCF3-679E806A3989}" type="slidenum">
              <a:rPr 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75845635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/>
          <p:cNvSpPr>
            <a:spLocks noGrp="1"/>
          </p:cNvSpPr>
          <p:nvPr>
            <p:ph/>
          </p:nvPr>
        </p:nvSpPr>
        <p:spPr>
          <a:xfrm>
            <a:off x="342900" y="366713"/>
            <a:ext cx="6172200" cy="7800975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7DBB956-B83F-4DC2-8F6C-1F4B84A34345}" type="slidenum">
              <a:rPr 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460102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1A9DB6D-327B-44FE-BAC6-517D90E6D2EC}" type="slidenum">
              <a:rPr 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862097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B13F578-879F-44D8-8A3C-3D5E9090CE65}" type="slidenum">
              <a:rPr 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569206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7630E43-DCF2-4B66-88C7-BDD12840B7FF}" type="slidenum">
              <a:rPr 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999615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E1FCAB2-C033-45BA-A1DB-8A5316620A23}" type="slidenum">
              <a:rPr 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723443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D2E27B2-A006-4EDB-9A53-4B20A4838678}" type="slidenum">
              <a:rPr 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562607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D22226D-1809-41CE-BB50-D04C08D8FF70}" type="slidenum">
              <a:rPr 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787344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AF8FFDB-6ADC-4AFE-B4E8-771277CC56CA}" type="slidenum">
              <a:rPr 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942576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2173E66-2611-45B8-BF66-7198D16F181D}" type="slidenum">
              <a:rPr 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932486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2B331C83-669A-4DAA-A0BC-974B85AD2F8D}" type="slidenum">
              <a:rPr lang="en-US">
                <a:solidFill>
                  <a:srgbClr val="000000"/>
                </a:solidFill>
              </a:rPr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104978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772" name="Rectangle 4"/>
          <p:cNvSpPr>
            <a:spLocks noChangeArrowheads="1"/>
          </p:cNvSpPr>
          <p:nvPr/>
        </p:nvSpPr>
        <p:spPr bwMode="auto">
          <a:xfrm>
            <a:off x="457200" y="333653"/>
            <a:ext cx="955326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dirty="0">
                <a:solidFill>
                  <a:srgbClr val="000000"/>
                </a:solidFill>
                <a:latin typeface="Calibri" pitchFamily="34" charset="0"/>
                <a:cs typeface="Times New Roman" pitchFamily="18" charset="0"/>
              </a:rPr>
              <a:t>Table S1</a:t>
            </a:r>
            <a:endParaRPr lang="en-US" altLang="en-US" dirty="0">
              <a:solidFill>
                <a:srgbClr val="000000"/>
              </a:solidFill>
              <a:latin typeface="Calibri" pitchFamily="34" charset="0"/>
            </a:endParaRPr>
          </a:p>
        </p:txBody>
      </p:sp>
      <p:graphicFrame>
        <p:nvGraphicFramePr>
          <p:cNvPr id="32959" name="Group 191"/>
          <p:cNvGraphicFramePr>
            <a:graphicFrameLocks noGrp="1"/>
          </p:cNvGraphicFramePr>
          <p:nvPr>
            <p:ph/>
          </p:nvPr>
        </p:nvGraphicFramePr>
        <p:xfrm>
          <a:off x="228600" y="762000"/>
          <a:ext cx="5562600" cy="2956560"/>
        </p:xfrm>
        <a:graphic>
          <a:graphicData uri="http://schemas.openxmlformats.org/drawingml/2006/table">
            <a:tbl>
              <a:tblPr/>
              <a:tblGrid>
                <a:gridCol w="1589088"/>
                <a:gridCol w="3973512"/>
              </a:tblGrid>
              <a:tr h="38100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charset="0"/>
                        </a:defRPr>
                      </a:lvl1pPr>
                      <a:lvl2pPr eaLnBrk="0" hangingPunct="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charset="0"/>
                        </a:defRPr>
                      </a:lvl2pPr>
                      <a:lvl3pPr eaLnBrk="0" hangingPunct="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charset="0"/>
                        </a:defRPr>
                      </a:lvl3pPr>
                      <a:lvl4pPr eaLnBrk="0" hangingPunct="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4pPr>
                      <a:lvl5pPr eaLnBrk="0" hangingPunct="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5pPr>
                      <a:lvl6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6pPr>
                      <a:lvl7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7pPr>
                      <a:lvl8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8pPr>
                      <a:lvl9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Times New Roman" pitchFamily="18" charset="0"/>
                      </a:endParaRPr>
                    </a:p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4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Times New Roman" pitchFamily="18" charset="0"/>
                        </a:rPr>
                        <a:t>Name</a:t>
                      </a:r>
                      <a:endParaRPr kumimoji="0" lang="en-US" altLang="en-US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horzOverflow="overflow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charset="0"/>
                        </a:defRPr>
                      </a:lvl1pPr>
                      <a:lvl2pPr eaLnBrk="0" hangingPunct="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charset="0"/>
                        </a:defRPr>
                      </a:lvl2pPr>
                      <a:lvl3pPr eaLnBrk="0" hangingPunct="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charset="0"/>
                        </a:defRPr>
                      </a:lvl3pPr>
                      <a:lvl4pPr eaLnBrk="0" hangingPunct="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4pPr>
                      <a:lvl5pPr eaLnBrk="0" hangingPunct="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5pPr>
                      <a:lvl6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6pPr>
                      <a:lvl7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7pPr>
                      <a:lvl8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8pPr>
                      <a:lvl9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4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Times New Roman" pitchFamily="18" charset="0"/>
                        </a:rPr>
                        <a:t>Sequence</a:t>
                      </a:r>
                      <a:endParaRPr kumimoji="0" lang="en-US" altLang="en-US" sz="14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2225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charset="0"/>
                        </a:defRPr>
                      </a:lvl1pPr>
                      <a:lvl2pPr eaLnBrk="0" hangingPunct="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charset="0"/>
                        </a:defRPr>
                      </a:lvl2pPr>
                      <a:lvl3pPr eaLnBrk="0" hangingPunct="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charset="0"/>
                        </a:defRPr>
                      </a:lvl3pPr>
                      <a:lvl4pPr eaLnBrk="0" hangingPunct="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4pPr>
                      <a:lvl5pPr eaLnBrk="0" hangingPunct="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5pPr>
                      <a:lvl6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6pPr>
                      <a:lvl7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7pPr>
                      <a:lvl8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8pPr>
                      <a:lvl9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Times New Roman" pitchFamily="18" charset="0"/>
                        </a:rPr>
                        <a:t>Stx1e-A-F1</a:t>
                      </a:r>
                      <a:endParaRPr kumimoji="0" lang="en-US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horzOverflow="overflow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charset="0"/>
                        </a:defRPr>
                      </a:lvl1pPr>
                      <a:lvl2pPr eaLnBrk="0" hangingPunct="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charset="0"/>
                        </a:defRPr>
                      </a:lvl2pPr>
                      <a:lvl3pPr eaLnBrk="0" hangingPunct="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charset="0"/>
                        </a:defRPr>
                      </a:lvl3pPr>
                      <a:lvl4pPr eaLnBrk="0" hangingPunct="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4pPr>
                      <a:lvl5pPr eaLnBrk="0" hangingPunct="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5pPr>
                      <a:lvl6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6pPr>
                      <a:lvl7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7pPr>
                      <a:lvl8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8pPr>
                      <a:lvl9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Times New Roman" pitchFamily="18" charset="0"/>
                        </a:rPr>
                        <a:t>5’-GGAATTCATATGATGATATTGATGATTTTCAGGG-3’</a:t>
                      </a:r>
                      <a:endParaRPr kumimoji="0" lang="en-US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20663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charset="0"/>
                        </a:defRPr>
                      </a:lvl1pPr>
                      <a:lvl2pPr eaLnBrk="0" hangingPunct="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charset="0"/>
                        </a:defRPr>
                      </a:lvl2pPr>
                      <a:lvl3pPr eaLnBrk="0" hangingPunct="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charset="0"/>
                        </a:defRPr>
                      </a:lvl3pPr>
                      <a:lvl4pPr eaLnBrk="0" hangingPunct="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4pPr>
                      <a:lvl5pPr eaLnBrk="0" hangingPunct="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5pPr>
                      <a:lvl6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6pPr>
                      <a:lvl7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7pPr>
                      <a:lvl8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8pPr>
                      <a:lvl9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Times New Roman" pitchFamily="18" charset="0"/>
                        </a:rPr>
                        <a:t>Stx1e-B-R2-stop</a:t>
                      </a:r>
                      <a:endParaRPr kumimoji="0" lang="en-US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horzOverflow="overflow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charset="0"/>
                        </a:defRPr>
                      </a:lvl1pPr>
                      <a:lvl2pPr eaLnBrk="0" hangingPunct="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charset="0"/>
                        </a:defRPr>
                      </a:lvl2pPr>
                      <a:lvl3pPr eaLnBrk="0" hangingPunct="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charset="0"/>
                        </a:defRPr>
                      </a:lvl3pPr>
                      <a:lvl4pPr eaLnBrk="0" hangingPunct="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4pPr>
                      <a:lvl5pPr eaLnBrk="0" hangingPunct="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5pPr>
                      <a:lvl6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6pPr>
                      <a:lvl7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7pPr>
                      <a:lvl8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8pPr>
                      <a:lvl9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Times New Roman" pitchFamily="18" charset="0"/>
                        </a:rPr>
                        <a:t>5’-GTGGTGCTCGAGTCAGCGAAAAATCACCT-3’</a:t>
                      </a:r>
                      <a:endParaRPr kumimoji="0" lang="en-US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20663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charset="0"/>
                        </a:defRPr>
                      </a:lvl1pPr>
                      <a:lvl2pPr eaLnBrk="0" hangingPunct="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charset="0"/>
                        </a:defRPr>
                      </a:lvl2pPr>
                      <a:lvl3pPr eaLnBrk="0" hangingPunct="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charset="0"/>
                        </a:defRPr>
                      </a:lvl3pPr>
                      <a:lvl4pPr eaLnBrk="0" hangingPunct="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4pPr>
                      <a:lvl5pPr eaLnBrk="0" hangingPunct="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5pPr>
                      <a:lvl6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6pPr>
                      <a:lvl7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7pPr>
                      <a:lvl8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8pPr>
                      <a:lvl9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Times New Roman" pitchFamily="18" charset="0"/>
                        </a:rPr>
                        <a:t>Stx1e-E167Q-F1</a:t>
                      </a:r>
                      <a:endParaRPr kumimoji="0" lang="en-US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horzOverflow="overflow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charset="0"/>
                        </a:defRPr>
                      </a:lvl1pPr>
                      <a:lvl2pPr eaLnBrk="0" hangingPunct="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charset="0"/>
                        </a:defRPr>
                      </a:lvl2pPr>
                      <a:lvl3pPr eaLnBrk="0" hangingPunct="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charset="0"/>
                        </a:defRPr>
                      </a:lvl3pPr>
                      <a:lvl4pPr eaLnBrk="0" hangingPunct="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4pPr>
                      <a:lvl5pPr eaLnBrk="0" hangingPunct="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5pPr>
                      <a:lvl6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6pPr>
                      <a:lvl7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7pPr>
                      <a:lvl8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8pPr>
                      <a:lvl9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Times New Roman" pitchFamily="18" charset="0"/>
                        </a:rPr>
                        <a:t>5’-GTGACAGCC</a:t>
                      </a:r>
                      <a:r>
                        <a:rPr kumimoji="0" lang="en-US" altLang="en-US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Calibri" pitchFamily="34" charset="0"/>
                          <a:cs typeface="Times New Roman" pitchFamily="18" charset="0"/>
                        </a:rPr>
                        <a:t>C</a:t>
                      </a:r>
                      <a:r>
                        <a:rPr kumimoji="0" lang="en-US" altLang="en-US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Times New Roman" pitchFamily="18" charset="0"/>
                        </a:rPr>
                        <a:t>AAGCTTTGCG-3’</a:t>
                      </a:r>
                      <a:endParaRPr kumimoji="0" lang="en-US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2225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charset="0"/>
                        </a:defRPr>
                      </a:lvl1pPr>
                      <a:lvl2pPr eaLnBrk="0" hangingPunct="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charset="0"/>
                        </a:defRPr>
                      </a:lvl2pPr>
                      <a:lvl3pPr eaLnBrk="0" hangingPunct="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charset="0"/>
                        </a:defRPr>
                      </a:lvl3pPr>
                      <a:lvl4pPr eaLnBrk="0" hangingPunct="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4pPr>
                      <a:lvl5pPr eaLnBrk="0" hangingPunct="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5pPr>
                      <a:lvl6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6pPr>
                      <a:lvl7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7pPr>
                      <a:lvl8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8pPr>
                      <a:lvl9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Times New Roman" pitchFamily="18" charset="0"/>
                        </a:rPr>
                        <a:t>Stx1e-E167Q-R1</a:t>
                      </a:r>
                      <a:endParaRPr kumimoji="0" lang="en-US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horzOverflow="overflow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charset="0"/>
                        </a:defRPr>
                      </a:lvl1pPr>
                      <a:lvl2pPr eaLnBrk="0" hangingPunct="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charset="0"/>
                        </a:defRPr>
                      </a:lvl2pPr>
                      <a:lvl3pPr eaLnBrk="0" hangingPunct="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charset="0"/>
                        </a:defRPr>
                      </a:lvl3pPr>
                      <a:lvl4pPr eaLnBrk="0" hangingPunct="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4pPr>
                      <a:lvl5pPr eaLnBrk="0" hangingPunct="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5pPr>
                      <a:lvl6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6pPr>
                      <a:lvl7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7pPr>
                      <a:lvl8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8pPr>
                      <a:lvl9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Times New Roman" pitchFamily="18" charset="0"/>
                        </a:rPr>
                        <a:t>5’-CGCAAAGCTT</a:t>
                      </a:r>
                      <a:r>
                        <a:rPr kumimoji="0" lang="en-US" altLang="en-US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Calibri" pitchFamily="34" charset="0"/>
                          <a:cs typeface="Times New Roman" pitchFamily="18" charset="0"/>
                        </a:rPr>
                        <a:t>G</a:t>
                      </a:r>
                      <a:r>
                        <a:rPr kumimoji="0" lang="en-US" altLang="en-US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Times New Roman" pitchFamily="18" charset="0"/>
                        </a:rPr>
                        <a:t>GGCTGTCAC-3’</a:t>
                      </a:r>
                      <a:endParaRPr kumimoji="0" lang="en-US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20663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charset="0"/>
                        </a:defRPr>
                      </a:lvl1pPr>
                      <a:lvl2pPr eaLnBrk="0" hangingPunct="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charset="0"/>
                        </a:defRPr>
                      </a:lvl2pPr>
                      <a:lvl3pPr eaLnBrk="0" hangingPunct="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charset="0"/>
                        </a:defRPr>
                      </a:lvl3pPr>
                      <a:lvl4pPr eaLnBrk="0" hangingPunct="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4pPr>
                      <a:lvl5pPr eaLnBrk="0" hangingPunct="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5pPr>
                      <a:lvl6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6pPr>
                      <a:lvl7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7pPr>
                      <a:lvl8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8pPr>
                      <a:lvl9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Times New Roman" pitchFamily="18" charset="0"/>
                        </a:rPr>
                        <a:t>Stx1e-spec-F1</a:t>
                      </a:r>
                      <a:endParaRPr kumimoji="0" lang="en-US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horzOverflow="overflow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charset="0"/>
                        </a:defRPr>
                      </a:lvl1pPr>
                      <a:lvl2pPr eaLnBrk="0" hangingPunct="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charset="0"/>
                        </a:defRPr>
                      </a:lvl2pPr>
                      <a:lvl3pPr eaLnBrk="0" hangingPunct="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charset="0"/>
                        </a:defRPr>
                      </a:lvl3pPr>
                      <a:lvl4pPr eaLnBrk="0" hangingPunct="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4pPr>
                      <a:lvl5pPr eaLnBrk="0" hangingPunct="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5pPr>
                      <a:lvl6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6pPr>
                      <a:lvl7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7pPr>
                      <a:lvl8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8pPr>
                      <a:lvl9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Times New Roman" pitchFamily="18" charset="0"/>
                        </a:rPr>
                        <a:t>5’-TATTGATGATTTTCAGGGGG-3’</a:t>
                      </a:r>
                      <a:endParaRPr kumimoji="0" lang="en-US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20663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charset="0"/>
                        </a:defRPr>
                      </a:lvl1pPr>
                      <a:lvl2pPr eaLnBrk="0" hangingPunct="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charset="0"/>
                        </a:defRPr>
                      </a:lvl2pPr>
                      <a:lvl3pPr eaLnBrk="0" hangingPunct="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charset="0"/>
                        </a:defRPr>
                      </a:lvl3pPr>
                      <a:lvl4pPr eaLnBrk="0" hangingPunct="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4pPr>
                      <a:lvl5pPr eaLnBrk="0" hangingPunct="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5pPr>
                      <a:lvl6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6pPr>
                      <a:lvl7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7pPr>
                      <a:lvl8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8pPr>
                      <a:lvl9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Times New Roman" pitchFamily="18" charset="0"/>
                        </a:rPr>
                        <a:t>Stx1e-spec-R1</a:t>
                      </a:r>
                      <a:endParaRPr kumimoji="0" lang="en-US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horzOverflow="overflow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charset="0"/>
                        </a:defRPr>
                      </a:lvl1pPr>
                      <a:lvl2pPr eaLnBrk="0" hangingPunct="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charset="0"/>
                        </a:defRPr>
                      </a:lvl2pPr>
                      <a:lvl3pPr eaLnBrk="0" hangingPunct="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charset="0"/>
                        </a:defRPr>
                      </a:lvl3pPr>
                      <a:lvl4pPr eaLnBrk="0" hangingPunct="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4pPr>
                      <a:lvl5pPr eaLnBrk="0" hangingPunct="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5pPr>
                      <a:lvl6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6pPr>
                      <a:lvl7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7pPr>
                      <a:lvl8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8pPr>
                      <a:lvl9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Times New Roman" pitchFamily="18" charset="0"/>
                        </a:rPr>
                        <a:t>5’-GCGTAAATTGTCAAACCGTT-3’</a:t>
                      </a:r>
                      <a:endParaRPr kumimoji="0" lang="en-US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2225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charset="0"/>
                        </a:defRPr>
                      </a:lvl1pPr>
                      <a:lvl2pPr eaLnBrk="0" hangingPunct="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charset="0"/>
                        </a:defRPr>
                      </a:lvl2pPr>
                      <a:lvl3pPr eaLnBrk="0" hangingPunct="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charset="0"/>
                        </a:defRPr>
                      </a:lvl3pPr>
                      <a:lvl4pPr eaLnBrk="0" hangingPunct="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4pPr>
                      <a:lvl5pPr eaLnBrk="0" hangingPunct="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5pPr>
                      <a:lvl6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6pPr>
                      <a:lvl7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7pPr>
                      <a:lvl8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8pPr>
                      <a:lvl9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wrbA-F1</a:t>
                      </a:r>
                    </a:p>
                  </a:txBody>
                  <a:tcPr horzOverflow="overflow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charset="0"/>
                        </a:defRPr>
                      </a:lvl1pPr>
                      <a:lvl2pPr eaLnBrk="0" hangingPunct="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charset="0"/>
                        </a:defRPr>
                      </a:lvl2pPr>
                      <a:lvl3pPr eaLnBrk="0" hangingPunct="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charset="0"/>
                        </a:defRPr>
                      </a:lvl3pPr>
                      <a:lvl4pPr eaLnBrk="0" hangingPunct="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4pPr>
                      <a:lvl5pPr eaLnBrk="0" hangingPunct="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5pPr>
                      <a:lvl6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6pPr>
                      <a:lvl7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7pPr>
                      <a:lvl8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8pPr>
                      <a:lvl9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’-ATGGCTAAAGTTCTGGTGCTCTATTAT-3’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20663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charset="0"/>
                        </a:defRPr>
                      </a:lvl1pPr>
                      <a:lvl2pPr eaLnBrk="0" hangingPunct="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charset="0"/>
                        </a:defRPr>
                      </a:lvl2pPr>
                      <a:lvl3pPr eaLnBrk="0" hangingPunct="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charset="0"/>
                        </a:defRPr>
                      </a:lvl3pPr>
                      <a:lvl4pPr eaLnBrk="0" hangingPunct="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4pPr>
                      <a:lvl5pPr eaLnBrk="0" hangingPunct="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5pPr>
                      <a:lvl6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6pPr>
                      <a:lvl7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7pPr>
                      <a:lvl8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8pPr>
                      <a:lvl9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</a:rPr>
                        <a:t>wrbA-R1</a:t>
                      </a:r>
                    </a:p>
                  </a:txBody>
                  <a:tcPr horzOverflow="overflow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charset="0"/>
                        </a:defRPr>
                      </a:lvl1pPr>
                      <a:lvl2pPr eaLnBrk="0" hangingPunct="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charset="0"/>
                        </a:defRPr>
                      </a:lvl2pPr>
                      <a:lvl3pPr eaLnBrk="0" hangingPunct="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charset="0"/>
                        </a:defRPr>
                      </a:lvl3pPr>
                      <a:lvl4pPr eaLnBrk="0" hangingPunct="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4pPr>
                      <a:lvl5pPr eaLnBrk="0" hangingPunct="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5pPr>
                      <a:lvl6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6pPr>
                      <a:lvl7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7pPr>
                      <a:lvl8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8pPr>
                      <a:lvl9pPr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’-TTAGCCGTTCAGTTTTTTGGC-3’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17720990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44</Words>
  <Application>Microsoft Office PowerPoint</Application>
  <PresentationFormat>On-screen Show (4:3)</PresentationFormat>
  <Paragraphs>2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Default Design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n, Noel</dc:creator>
  <cp:lastModifiedBy>Lin, Noel</cp:lastModifiedBy>
  <cp:revision>9</cp:revision>
  <dcterms:created xsi:type="dcterms:W3CDTF">2016-02-04T17:38:19Z</dcterms:created>
  <dcterms:modified xsi:type="dcterms:W3CDTF">2016-02-04T17:58:09Z</dcterms:modified>
</cp:coreProperties>
</file>